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81497"/>
  </p:normalViewPr>
  <p:slideViewPr>
    <p:cSldViewPr snapToGrid="0" snapToObjects="1">
      <p:cViewPr varScale="1">
        <p:scale>
          <a:sx n="99" d="100"/>
          <a:sy n="99" d="100"/>
        </p:scale>
        <p:origin x="150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72183F-080B-F846-89F6-C3F187B37DDA}" type="datetimeFigureOut">
              <a:rPr lang="en-US" smtClean="0"/>
              <a:t>7/8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D5306F-19C3-4749-A468-377834CC7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0854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uthor’s note: This is included as an example of a topic selected by faculty. May be adapted to suit local needs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D5306F-19C3-4749-A468-377834CC78A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9143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w fever definition in elderly: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ngle oral 100℉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wo oral temperatures of 99℉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 degrees higher than baselin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D5306F-19C3-4749-A468-377834CC78A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9783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art 6/kg, positive end-expiratory pressure (PEEP) of 8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void prolonged 100% fraction of inspired oxygen (FiO2) but okay if going right upstairs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ow recruitable are they? If yes, consider higher PEEP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 a higher RR than usual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2 goal Low 90s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f PEEP isn’t working try Airway Pressure Release Ventilation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F not, try paralysis, then prone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CU patients Decadron anticoagulant, 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finitely prophylactic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ybe 0.5/kg bid LMWH if intubated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D5306F-19C3-4749-A468-377834CC78A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47878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DC Definition: Includes all of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ever documented &gt; 100.4 or subjective &gt; 24 hours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b evidence of inflammation:</a:t>
            </a:r>
          </a:p>
          <a:p>
            <a:pPr lvl="1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levation of any of CRP, ESR, fibrinogen, procalcitonin, d-dimer, ferritin, LDH, IL-6</a:t>
            </a:r>
          </a:p>
          <a:p>
            <a:pPr lvl="1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ow neutrophils, lymphocytes, or albumin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volvement of 2 or more organ systems: Cardio, pulmonary, renal, neuro, hematologic (eg, coagulopathy), GI, derm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llness is severe enough to require hospitalization under 21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 clear alternative diagnosis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cent COVID infection/exposure:</a:t>
            </a:r>
          </a:p>
          <a:p>
            <a:pPr lvl="1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ve PCR/antigen test</a:t>
            </a:r>
          </a:p>
          <a:p>
            <a:pPr lvl="1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ve serology (1-2 weeks after infection)</a:t>
            </a:r>
          </a:p>
          <a:p>
            <a:pPr lvl="1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redible COVID exposure in the 4 weeks before symptom onset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HO differences: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ly goes to 19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quires 3 days of fever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eatment: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VIG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eroids either with IVIG or if IVIG fails (upstairs medicine)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akinra (IL-1 blocker)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ocilizumab (IL-6 blocker)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mdesivir probably not helpful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ggressive DVT prevention</a:t>
            </a:r>
          </a:p>
          <a:p>
            <a:b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</a:b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S-A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sically the same syndrome in adults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se reports: 27 young adults with very elevated inflammatory markers; 26 were racial minorities, 10 needed ICU, 3 died, and in 2, first symptoms were major strokes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ny had no preceding respiratory symptom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D5306F-19C3-4749-A468-377834CC78A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54301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D5306F-19C3-4749-A468-377834CC78A1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182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D9A8D9-957C-B546-9AE1-3C77682FDE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0DEF8A8-7893-BB44-BB8D-39D34597CB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5DEAC7-2757-7041-BF90-BB61EBC1D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3917-72A2-A74A-9E39-5F6AA6834780}" type="datetimeFigureOut">
              <a:rPr lang="en-US" smtClean="0"/>
              <a:t>7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4D4F55-8C6C-3646-A1B3-62DD57C4F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6BE68F-58C1-E144-8622-03FA5C0B3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03F28-DDA2-E742-B63A-78CB87729F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653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C99C2C-8686-E748-9C4B-D88BE8F3F3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C3748E-75B9-2549-99AF-2F03F26100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847847-D081-3B4B-94D9-1E6C04DEF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3917-72A2-A74A-9E39-5F6AA6834780}" type="datetimeFigureOut">
              <a:rPr lang="en-US" smtClean="0"/>
              <a:t>7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A441F5-49C7-E34F-97AA-41ED3B9483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341104-25DB-3541-A570-0E5D33457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03F28-DDA2-E742-B63A-78CB87729F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368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E225A1-946D-E640-B980-765C8DB0B8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25280EC-F6F4-8B4A-AB5A-0A4BEE2FDA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48E966-D2CE-D646-9259-B507903101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3917-72A2-A74A-9E39-5F6AA6834780}" type="datetimeFigureOut">
              <a:rPr lang="en-US" smtClean="0"/>
              <a:t>7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99F31A-C8BB-ED40-BECC-6F9420514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7B5686-D4C4-D24A-A138-684E6DB30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03F28-DDA2-E742-B63A-78CB87729F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305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CCE0DC-39DC-3E46-A2DE-D95D7BBD42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0C6549-CCD8-3A42-919A-5CB1176577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7A15BA-B0AA-5540-A1C1-9252AD628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3917-72A2-A74A-9E39-5F6AA6834780}" type="datetimeFigureOut">
              <a:rPr lang="en-US" smtClean="0"/>
              <a:t>7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B7B84-DAC3-C144-9F7F-B69FACDE1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2EFEE1-3A68-D349-97B5-2E91AE46FA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03F28-DDA2-E742-B63A-78CB87729F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01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597C60-5D30-EC43-A12D-6A04737FFF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A78BA6-ACAF-1D49-84CF-B581D5F219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82979B-080E-8742-905C-65254DA83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3917-72A2-A74A-9E39-5F6AA6834780}" type="datetimeFigureOut">
              <a:rPr lang="en-US" smtClean="0"/>
              <a:t>7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BA7EFF-1E67-444E-8174-5544CDAF6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4C58FB-0148-F04E-9FC2-BB1B998FD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03F28-DDA2-E742-B63A-78CB87729F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4932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270F4C-2CDB-9647-AF19-D61C2386F1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79EA43-B851-4148-A820-CC6FADDF87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D23C37-0EE5-294A-A750-64C6C3EF4B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7C68CD-388C-A14D-AB32-BEEDC3E61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3917-72A2-A74A-9E39-5F6AA6834780}" type="datetimeFigureOut">
              <a:rPr lang="en-US" smtClean="0"/>
              <a:t>7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EF89B7-FDEE-B349-B9E2-92D54587E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3EBB7D-0B34-1849-8C38-180C13944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03F28-DDA2-E742-B63A-78CB87729F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298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0AA386-76EA-C842-9C6D-7C8603C907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4A61FD-91FF-DD42-8A87-736B7D8B51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5836D7-F9A2-7E4A-9E20-91C8878640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E796C74-F13D-5F43-9131-459ECB0C86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D9A930-A66A-B24D-B19C-D674C166D4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767E6D4-4432-354F-BAA9-74038D977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3917-72A2-A74A-9E39-5F6AA6834780}" type="datetimeFigureOut">
              <a:rPr lang="en-US" smtClean="0"/>
              <a:t>7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B9D549-E513-5740-B044-85EFB425B8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B162EA-EAAA-BE47-8AAF-04B479503B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03F28-DDA2-E742-B63A-78CB87729F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994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E3DFBF-0622-4643-94B6-4CC4383F8E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DCCC1E-D25D-9248-A301-0E8E9ABDE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3917-72A2-A74A-9E39-5F6AA6834780}" type="datetimeFigureOut">
              <a:rPr lang="en-US" smtClean="0"/>
              <a:t>7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8FE787-B64A-CE47-8DBF-1104D3D78E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BAEE58-96C0-E842-B202-DEB64D2D5C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03F28-DDA2-E742-B63A-78CB87729F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702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6EEF045-1D8C-0C4D-A6BB-9D720B9F2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3917-72A2-A74A-9E39-5F6AA6834780}" type="datetimeFigureOut">
              <a:rPr lang="en-US" smtClean="0"/>
              <a:t>7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A23631-0869-214A-A916-E2F034284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841EC6-F98C-2A48-8A53-34030348E8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03F28-DDA2-E742-B63A-78CB87729F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611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570052-D146-8A48-9E9C-8E8C30645C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BAA4BF-055A-154C-B633-91C0DCFA26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2322D6-366C-224B-91C9-6A0A84CD5F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4314B6-C7CA-5D44-9A69-F8604E8BF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3917-72A2-A74A-9E39-5F6AA6834780}" type="datetimeFigureOut">
              <a:rPr lang="en-US" smtClean="0"/>
              <a:t>7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40F552-4F0F-694E-A936-B21EBDF83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946028-BC46-474C-800A-9D8F6299A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03F28-DDA2-E742-B63A-78CB87729F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4044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C56A40-B14C-8647-9CB2-E5B2C577D8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B80145-E5A1-ED40-8D22-592D685D7A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A56D1B-5AD4-484C-A601-1BCFF6D99A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B3FA70-2D50-C040-9137-347B233A58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3917-72A2-A74A-9E39-5F6AA6834780}" type="datetimeFigureOut">
              <a:rPr lang="en-US" smtClean="0"/>
              <a:t>7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1D1B71-35E7-2D48-B76E-BD42F2B8BC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951BC8-20D5-B748-BBFA-D60ABB266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03F28-DDA2-E742-B63A-78CB87729F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015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0DB1C67-2935-3940-9312-212AEB29D8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567224-B479-3044-A867-403412E9C7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01DA6E-0F2C-A843-815A-2D5F11B2E00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23917-72A2-A74A-9E39-5F6AA6834780}" type="datetimeFigureOut">
              <a:rPr lang="en-US" smtClean="0"/>
              <a:t>7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E5C092-8824-3C44-810B-B52E88858F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07AB21-1106-C944-9BEA-9872B874A6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003F28-DDA2-E742-B63A-78CB87729F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505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045AB5-69B7-654A-BDBF-D293DF93B565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6400" dirty="0"/>
              <a:t>COVID-19 </a:t>
            </a:r>
            <a:br>
              <a:rPr lang="en-US" dirty="0"/>
            </a:br>
            <a:r>
              <a:rPr lang="en-US" sz="4400" dirty="0"/>
              <a:t>Updates for Emergency Physician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ECCA362-536B-7A44-854A-1D00A90CE002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[Presenter]</a:t>
            </a:r>
          </a:p>
          <a:p>
            <a:r>
              <a:rPr lang="en-US" dirty="0"/>
              <a:t>[Venue]</a:t>
            </a:r>
          </a:p>
          <a:p>
            <a:r>
              <a:rPr lang="en-US" dirty="0"/>
              <a:t>[Date]</a:t>
            </a:r>
          </a:p>
          <a:p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A443100-BB3D-D6B3-953D-C9EE57D7CA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42398" y="6212829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54445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0FFDA3-7BA3-A144-ACB5-03F2AEEA42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jectiv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CFCE49-B762-2849-ADBD-A537E37A42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Updates to recommendations for care of elderly people, athletes, and general return to work</a:t>
            </a:r>
          </a:p>
          <a:p>
            <a:r>
              <a:rPr lang="en-US" dirty="0"/>
              <a:t> Most recent literature for pharmacologic therapy</a:t>
            </a:r>
          </a:p>
          <a:p>
            <a:r>
              <a:rPr lang="en-US" dirty="0"/>
              <a:t>Critical care insights</a:t>
            </a:r>
          </a:p>
          <a:p>
            <a:r>
              <a:rPr lang="en-US" dirty="0"/>
              <a:t>Discussion of MIS-C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87145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ECFD90-2E33-5E40-B00E-2766F85FD0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Geriatric Patien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BDAC9C-9195-B848-9EFE-9CF3A4B8AE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New definition of “fever”:</a:t>
            </a:r>
          </a:p>
          <a:p>
            <a:pPr lvl="1"/>
            <a:r>
              <a:rPr lang="en-US" dirty="0"/>
              <a:t>Single oral temperature </a:t>
            </a:r>
            <a:r>
              <a:rPr lang="en-US" u="sng" dirty="0"/>
              <a:t>&gt;</a:t>
            </a:r>
            <a:r>
              <a:rPr lang="en-US" dirty="0"/>
              <a:t> 100 ℉</a:t>
            </a:r>
          </a:p>
          <a:p>
            <a:pPr lvl="1"/>
            <a:r>
              <a:rPr lang="en-US" dirty="0"/>
              <a:t>Two oral temperatures </a:t>
            </a:r>
            <a:r>
              <a:rPr lang="en-US" u="sng" dirty="0"/>
              <a:t>&gt;</a:t>
            </a:r>
            <a:r>
              <a:rPr lang="en-US" dirty="0"/>
              <a:t> 99 ℉</a:t>
            </a:r>
          </a:p>
          <a:p>
            <a:pPr lvl="1"/>
            <a:r>
              <a:rPr lang="en-US" dirty="0"/>
              <a:t>Temperature 2 degrees higher than baseline</a:t>
            </a:r>
          </a:p>
        </p:txBody>
      </p:sp>
    </p:spTree>
    <p:extLst>
      <p:ext uri="{BB962C8B-B14F-4D97-AF65-F5344CB8AC3E}">
        <p14:creationId xmlns:p14="http://schemas.microsoft.com/office/powerpoint/2010/main" val="23120373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A4ED5-90E5-2446-8567-60A4CA3EA6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turn to Work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B2406A-28B4-4C46-8308-E635157948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6877050" cy="4351338"/>
          </a:xfrm>
        </p:spPr>
        <p:txBody>
          <a:bodyPr/>
          <a:lstStyle/>
          <a:p>
            <a:r>
              <a:rPr lang="en-US" dirty="0"/>
              <a:t>Testing-based strategy no longer recommended</a:t>
            </a:r>
          </a:p>
          <a:p>
            <a:r>
              <a:rPr lang="en-US" dirty="0"/>
              <a:t>Symptom-based strategy</a:t>
            </a:r>
          </a:p>
          <a:p>
            <a:pPr lvl="1"/>
            <a:r>
              <a:rPr lang="en-US" dirty="0"/>
              <a:t>No fever for 24 hours without antipyretics</a:t>
            </a:r>
          </a:p>
          <a:p>
            <a:pPr lvl="1"/>
            <a:r>
              <a:rPr lang="en-US" dirty="0"/>
              <a:t>Other symptoms improving</a:t>
            </a:r>
          </a:p>
          <a:p>
            <a:pPr lvl="1"/>
            <a:r>
              <a:rPr lang="en-US" dirty="0"/>
              <a:t>10 days from SYMPTOM onset if mild, 20 days if hospitalized or immunocompromised</a:t>
            </a:r>
          </a:p>
          <a:p>
            <a:pPr marL="457200" lvl="1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36371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9B303C-9F9E-7B4E-A423-D09180DD1C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harmacotherap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43314A-E0F2-834F-806C-33FFA57CF5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Negative trial of high dose Famotidine</a:t>
            </a:r>
          </a:p>
          <a:p>
            <a:r>
              <a:rPr lang="en-US" dirty="0"/>
              <a:t>Clinical equipoise for aspirin</a:t>
            </a:r>
          </a:p>
          <a:p>
            <a:r>
              <a:rPr lang="en-US" dirty="0"/>
              <a:t>Monoclonal antibody therapy</a:t>
            </a:r>
          </a:p>
          <a:p>
            <a:pPr lvl="1"/>
            <a:r>
              <a:rPr lang="en-US" dirty="0"/>
              <a:t>Not helpful in late disease</a:t>
            </a:r>
          </a:p>
          <a:p>
            <a:pPr lvl="1"/>
            <a:r>
              <a:rPr lang="en-US" dirty="0"/>
              <a:t>May be helpful to prevent progression, also a trial as a prophylactic in Health Care Workers</a:t>
            </a:r>
          </a:p>
          <a:p>
            <a:r>
              <a:rPr lang="en-US" dirty="0"/>
              <a:t>Remdesivir = mixed data</a:t>
            </a:r>
          </a:p>
        </p:txBody>
      </p:sp>
    </p:spTree>
    <p:extLst>
      <p:ext uri="{BB962C8B-B14F-4D97-AF65-F5344CB8AC3E}">
        <p14:creationId xmlns:p14="http://schemas.microsoft.com/office/powerpoint/2010/main" val="34561110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40706A-39E4-F246-B314-A8BF9D0308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ritical Care Though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2F6484-54DF-B149-80FB-78B5FFFE332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Initial ventilator settings: 6-8 cc/kg ideal body weight, 8 of PEEP, higher rate</a:t>
            </a:r>
          </a:p>
          <a:p>
            <a:r>
              <a:rPr lang="en-US" dirty="0"/>
              <a:t>Try to avoid prolonged 100% FiO2. Goal saturation is low 90s</a:t>
            </a:r>
          </a:p>
          <a:p>
            <a:r>
              <a:rPr lang="en-US" dirty="0"/>
              <a:t>Give Dexamethasone, or some other steroid</a:t>
            </a:r>
          </a:p>
          <a:p>
            <a:r>
              <a:rPr lang="en-US" dirty="0"/>
              <a:t>Anticoagulation:</a:t>
            </a:r>
          </a:p>
          <a:p>
            <a:pPr lvl="1"/>
            <a:r>
              <a:rPr lang="en-US" dirty="0"/>
              <a:t>Consider 0.5 mg/kg Low Molecular Weight Heparin (LMWH) or equivalent if intubated</a:t>
            </a:r>
          </a:p>
        </p:txBody>
      </p:sp>
    </p:spTree>
    <p:extLst>
      <p:ext uri="{BB962C8B-B14F-4D97-AF65-F5344CB8AC3E}">
        <p14:creationId xmlns:p14="http://schemas.microsoft.com/office/powerpoint/2010/main" val="41422901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CAB649-DDEE-2847-8C27-F17D33298E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MIS-C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4CB717-4A7A-D34D-A737-12C99C8817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Definition</a:t>
            </a:r>
          </a:p>
          <a:p>
            <a:pPr lvl="1"/>
            <a:r>
              <a:rPr lang="en-US" dirty="0"/>
              <a:t>Age &lt; 21</a:t>
            </a:r>
          </a:p>
          <a:p>
            <a:pPr lvl="1"/>
            <a:r>
              <a:rPr lang="en-US" dirty="0"/>
              <a:t>Fever</a:t>
            </a:r>
          </a:p>
          <a:p>
            <a:pPr lvl="1"/>
            <a:r>
              <a:rPr lang="en-US" dirty="0"/>
              <a:t>Evidence of inflammation</a:t>
            </a:r>
          </a:p>
          <a:p>
            <a:pPr lvl="1"/>
            <a:r>
              <a:rPr lang="en-US" dirty="0"/>
              <a:t>Recent COVID infection/exposure</a:t>
            </a:r>
          </a:p>
          <a:p>
            <a:r>
              <a:rPr lang="en-US" dirty="0"/>
              <a:t>Treatment</a:t>
            </a:r>
          </a:p>
          <a:p>
            <a:pPr lvl="1"/>
            <a:r>
              <a:rPr lang="en-US" dirty="0"/>
              <a:t>IV Immunoglobulin therapy (IVIG)</a:t>
            </a:r>
          </a:p>
          <a:p>
            <a:pPr lvl="1"/>
            <a:r>
              <a:rPr lang="en-US" dirty="0"/>
              <a:t>Steroids</a:t>
            </a:r>
          </a:p>
          <a:p>
            <a:pPr lvl="1"/>
            <a:r>
              <a:rPr lang="en-US" dirty="0"/>
              <a:t>Biologic agents</a:t>
            </a:r>
          </a:p>
          <a:p>
            <a:r>
              <a:rPr lang="en-US" dirty="0"/>
              <a:t>This can occur in adults too</a:t>
            </a:r>
          </a:p>
        </p:txBody>
      </p:sp>
    </p:spTree>
    <p:extLst>
      <p:ext uri="{BB962C8B-B14F-4D97-AF65-F5344CB8AC3E}">
        <p14:creationId xmlns:p14="http://schemas.microsoft.com/office/powerpoint/2010/main" val="9090786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65F5E7-5539-A34E-8937-4DA8248707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FB5ADF-EFB6-D046-8159-4272244092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/>
              <a:t>CDC. Multisystem Inflammatory Syndrome (MIS). Centers for Disease Control and Prevention. Published February 11, 2020. https://</a:t>
            </a:r>
            <a:r>
              <a:rPr lang="en-US" dirty="0" err="1"/>
              <a:t>www.cdc.gov</a:t>
            </a:r>
            <a:r>
              <a:rPr lang="en-US" dirty="0"/>
              <a:t>/mis/mis-c/hcp/</a:t>
            </a:r>
            <a:r>
              <a:rPr lang="en-US" dirty="0" err="1"/>
              <a:t>index.html</a:t>
            </a:r>
            <a:endParaRPr lang="en-US" dirty="0"/>
          </a:p>
          <a:p>
            <a:r>
              <a:rPr lang="en-US" dirty="0"/>
              <a:t>Multisystem Inflammatory Syndrome in Children (MIS-C) Interim Guidance. </a:t>
            </a:r>
            <a:r>
              <a:rPr lang="en-US" dirty="0" err="1"/>
              <a:t>www.aap.org</a:t>
            </a:r>
            <a:r>
              <a:rPr lang="en-US" dirty="0"/>
              <a:t>. Accessed April 7, 2022. https://</a:t>
            </a:r>
            <a:r>
              <a:rPr lang="en-US" dirty="0" err="1"/>
              <a:t>www.aap.org</a:t>
            </a:r>
            <a:r>
              <a:rPr lang="en-US" dirty="0"/>
              <a:t>/</a:t>
            </a:r>
            <a:r>
              <a:rPr lang="en-US" dirty="0" err="1"/>
              <a:t>en</a:t>
            </a:r>
            <a:r>
              <a:rPr lang="en-US" dirty="0"/>
              <a:t>/pages/2019-novel-coronavirus-covid-19-infections/clinical-guidance/multisystem-inflammatory-syndrome-in-children-mis-c-interim-guidance </a:t>
            </a:r>
          </a:p>
          <a:p>
            <a:r>
              <a:rPr lang="en-US" dirty="0"/>
              <a:t>Centers for Disease Control and Prevention. Interim Clinical Guidance for Management of Patients with Confirmed 2019 Novel Coronavirus (2019-nCoV) Infection. Centers for Disease Control and Prevention. Published 2020. https://</a:t>
            </a:r>
            <a:r>
              <a:rPr lang="en-US" dirty="0" err="1"/>
              <a:t>www.cdc.gov</a:t>
            </a:r>
            <a:r>
              <a:rPr lang="en-US" dirty="0"/>
              <a:t>/coronavirus/2019-ncov/hcp/clinical-guidance-management-</a:t>
            </a:r>
            <a:r>
              <a:rPr lang="en-US" dirty="0" err="1"/>
              <a:t>patients.html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8661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718</Words>
  <Application>Microsoft Macintosh PowerPoint</Application>
  <PresentationFormat>Widescreen</PresentationFormat>
  <Paragraphs>95</Paragraphs>
  <Slides>8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COVID-19  Updates for Emergency Physicians</vt:lpstr>
      <vt:lpstr>Objectives</vt:lpstr>
      <vt:lpstr>Geriatric Patients</vt:lpstr>
      <vt:lpstr>Return to Work</vt:lpstr>
      <vt:lpstr>Pharmacotherapy</vt:lpstr>
      <vt:lpstr>Critical Care Thoughts</vt:lpstr>
      <vt:lpstr>MIS-C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VID-19  Updates for Emergency Physicians</dc:title>
  <dc:creator>Willner, Keith</dc:creator>
  <cp:lastModifiedBy>Alisa Wray</cp:lastModifiedBy>
  <cp:revision>11</cp:revision>
  <dcterms:created xsi:type="dcterms:W3CDTF">2021-10-11T13:01:08Z</dcterms:created>
  <dcterms:modified xsi:type="dcterms:W3CDTF">2022-07-08T19:28:45Z</dcterms:modified>
</cp:coreProperties>
</file>